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8" r:id="rId3"/>
  </p:sldIdLst>
  <p:sldSz cx="12192000" cy="6858000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4:$M$5</c:f>
              <c:numCache>
                <c:formatCode>####.0000</c:formatCode>
                <c:ptCount val="2"/>
                <c:pt idx="0">
                  <c:v>-0.17604453820909269</c:v>
                </c:pt>
                <c:pt idx="1">
                  <c:v>-0.29102410383188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C9-463F-B71D-FD8C4B6779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70240"/>
        <c:axId val="657059656"/>
      </c:barChart>
      <c:catAx>
        <c:axId val="657070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59656"/>
        <c:crosses val="autoZero"/>
        <c:auto val="1"/>
        <c:lblAlgn val="ctr"/>
        <c:lblOffset val="100"/>
        <c:noMultiLvlLbl val="0"/>
      </c:catAx>
      <c:valAx>
        <c:axId val="657059656"/>
        <c:scaling>
          <c:orientation val="minMax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0240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31:$L$32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31:$M$32</c:f>
              <c:numCache>
                <c:formatCode>####.0000</c:formatCode>
                <c:ptCount val="2"/>
                <c:pt idx="0">
                  <c:v>-0.29481669010782607</c:v>
                </c:pt>
                <c:pt idx="1">
                  <c:v>-0.441265142150801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1D-4ADC-9CEA-9CEFEE9EC4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8590968"/>
        <c:axId val="678595280"/>
      </c:barChart>
      <c:catAx>
        <c:axId val="678590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95280"/>
        <c:crosses val="autoZero"/>
        <c:auto val="1"/>
        <c:lblAlgn val="ctr"/>
        <c:lblOffset val="100"/>
        <c:noMultiLvlLbl val="0"/>
      </c:catAx>
      <c:valAx>
        <c:axId val="678595280"/>
        <c:scaling>
          <c:orientation val="minMax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90968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34:$L$3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34:$M$35</c:f>
              <c:numCache>
                <c:formatCode>####.0000</c:formatCode>
                <c:ptCount val="2"/>
                <c:pt idx="0">
                  <c:v>0.15871917487107295</c:v>
                </c:pt>
                <c:pt idx="1">
                  <c:v>-0.139127317676142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0B-4326-B225-6DF62710EE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8592144"/>
        <c:axId val="678592536"/>
      </c:barChart>
      <c:catAx>
        <c:axId val="678592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92536"/>
        <c:crosses val="autoZero"/>
        <c:auto val="1"/>
        <c:lblAlgn val="ctr"/>
        <c:lblOffset val="100"/>
        <c:noMultiLvlLbl val="0"/>
      </c:catAx>
      <c:valAx>
        <c:axId val="678592536"/>
        <c:scaling>
          <c:orientation val="minMax"/>
        </c:scaling>
        <c:delete val="0"/>
        <c:axPos val="l"/>
        <c:numFmt formatCode="#,##0.0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9214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7:$M$8</c:f>
              <c:numCache>
                <c:formatCode>####.0000</c:formatCode>
                <c:ptCount val="2"/>
                <c:pt idx="0">
                  <c:v>-0.20935911861228479</c:v>
                </c:pt>
                <c:pt idx="1">
                  <c:v>-0.27631273176761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64-44CA-92E9-356CA9EFF8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9456"/>
        <c:axId val="657068672"/>
      </c:barChart>
      <c:catAx>
        <c:axId val="657069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8672"/>
        <c:crosses val="autoZero"/>
        <c:auto val="1"/>
        <c:lblAlgn val="ctr"/>
        <c:lblOffset val="100"/>
        <c:noMultiLvlLbl val="0"/>
      </c:catAx>
      <c:valAx>
        <c:axId val="657068672"/>
        <c:scaling>
          <c:orientation val="minMax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9456"/>
        <c:crosses val="autoZero"/>
        <c:crossBetween val="between"/>
        <c:majorUnit val="0.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13:$M$14</c:f>
              <c:numCache>
                <c:formatCode>####.0000</c:formatCode>
                <c:ptCount val="2"/>
                <c:pt idx="0">
                  <c:v>1.4997655883731836E-2</c:v>
                </c:pt>
                <c:pt idx="1">
                  <c:v>3.348640296662545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E0-442E-8C54-38902EDEC0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5144"/>
        <c:axId val="657067104"/>
      </c:barChart>
      <c:catAx>
        <c:axId val="657065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7104"/>
        <c:crosses val="autoZero"/>
        <c:auto val="1"/>
        <c:lblAlgn val="ctr"/>
        <c:lblOffset val="100"/>
        <c:noMultiLvlLbl val="0"/>
      </c:catAx>
      <c:valAx>
        <c:axId val="657067104"/>
        <c:scaling>
          <c:orientation val="minMax"/>
        </c:scaling>
        <c:delete val="0"/>
        <c:axPos val="l"/>
        <c:numFmt formatCode="#,##0.00_);[Red]\(#,##0.0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5144"/>
        <c:crosses val="autoZero"/>
        <c:crossBetween val="between"/>
        <c:majorUnit val="1.0000000000000002E-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19:$L$20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19:$M$20</c:f>
              <c:numCache>
                <c:formatCode>####.0000</c:formatCode>
                <c:ptCount val="2"/>
                <c:pt idx="0">
                  <c:v>0.16356727613689612</c:v>
                </c:pt>
                <c:pt idx="1">
                  <c:v>-2.80556242274411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43-4F30-AB3B-51080B60CA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5536"/>
        <c:axId val="657067888"/>
      </c:barChart>
      <c:catAx>
        <c:axId val="657065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7888"/>
        <c:crosses val="autoZero"/>
        <c:auto val="1"/>
        <c:lblAlgn val="ctr"/>
        <c:lblOffset val="100"/>
        <c:noMultiLvlLbl val="0"/>
      </c:catAx>
      <c:valAx>
        <c:axId val="657067888"/>
        <c:scaling>
          <c:orientation val="minMax"/>
        </c:scaling>
        <c:delete val="0"/>
        <c:axPos val="l"/>
        <c:numFmt formatCode="#,##0.0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553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22:$M$23</c:f>
              <c:numCache>
                <c:formatCode>####.0000</c:formatCode>
                <c:ptCount val="2"/>
                <c:pt idx="0">
                  <c:v>0.11219081106422776</c:v>
                </c:pt>
                <c:pt idx="1">
                  <c:v>2.649938195302818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FF-4CE6-8997-B9FFE55299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68280"/>
        <c:axId val="657072984"/>
      </c:barChart>
      <c:catAx>
        <c:axId val="657068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2984"/>
        <c:crosses val="autoZero"/>
        <c:auto val="1"/>
        <c:lblAlgn val="ctr"/>
        <c:lblOffset val="100"/>
        <c:noMultiLvlLbl val="0"/>
      </c:catAx>
      <c:valAx>
        <c:axId val="657072984"/>
        <c:scaling>
          <c:orientation val="minMax"/>
        </c:scaling>
        <c:delete val="0"/>
        <c:axPos val="l"/>
        <c:numFmt formatCode="#,##0.00_);[Red]\(#,##0.0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6828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4:$M$5</c:f>
              <c:numCache>
                <c:formatCode>####.0000</c:formatCode>
                <c:ptCount val="2"/>
                <c:pt idx="0">
                  <c:v>-0.17604453820909269</c:v>
                </c:pt>
                <c:pt idx="1">
                  <c:v>-0.29102410383188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3D-427B-84B9-CDF73ECAE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74160"/>
        <c:axId val="657071808"/>
      </c:barChart>
      <c:catAx>
        <c:axId val="65707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1808"/>
        <c:crosses val="autoZero"/>
        <c:auto val="1"/>
        <c:lblAlgn val="ctr"/>
        <c:lblOffset val="100"/>
        <c:noMultiLvlLbl val="0"/>
      </c:catAx>
      <c:valAx>
        <c:axId val="657071808"/>
        <c:scaling>
          <c:orientation val="minMax"/>
        </c:scaling>
        <c:delete val="0"/>
        <c:axPos val="l"/>
        <c:numFmt formatCode="#,##0.0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416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19:$L$20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19:$M$20</c:f>
              <c:numCache>
                <c:formatCode>####.0000</c:formatCode>
                <c:ptCount val="2"/>
                <c:pt idx="0">
                  <c:v>0.16356727613689612</c:v>
                </c:pt>
                <c:pt idx="1">
                  <c:v>-2.80556242274411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AF-4E46-BA05-DF02A7C678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73376"/>
        <c:axId val="657071024"/>
      </c:barChart>
      <c:catAx>
        <c:axId val="657073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1024"/>
        <c:crosses val="autoZero"/>
        <c:auto val="1"/>
        <c:lblAlgn val="ctr"/>
        <c:lblOffset val="100"/>
        <c:noMultiLvlLbl val="0"/>
      </c:catAx>
      <c:valAx>
        <c:axId val="657071024"/>
        <c:scaling>
          <c:orientation val="minMax"/>
        </c:scaling>
        <c:delete val="0"/>
        <c:axPos val="l"/>
        <c:numFmt formatCode="#,##0.0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337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25:$M$26</c:f>
              <c:numCache>
                <c:formatCode>####.0000</c:formatCode>
                <c:ptCount val="2"/>
                <c:pt idx="0">
                  <c:v>6.514205344585193E-2</c:v>
                </c:pt>
                <c:pt idx="1">
                  <c:v>4.66260815822006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15-4514-94D7-D1FF967A51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073768"/>
        <c:axId val="678584304"/>
      </c:barChart>
      <c:catAx>
        <c:axId val="657073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84304"/>
        <c:crosses val="autoZero"/>
        <c:auto val="1"/>
        <c:lblAlgn val="ctr"/>
        <c:lblOffset val="100"/>
        <c:noMultiLvlLbl val="0"/>
      </c:catAx>
      <c:valAx>
        <c:axId val="678584304"/>
        <c:scaling>
          <c:orientation val="minMax"/>
        </c:scaling>
        <c:delete val="0"/>
        <c:axPos val="l"/>
        <c:numFmt formatCode="#,##0.00_);[Red]\(#,##0.0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707376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6!$L$4:$L$5</c:f>
              <c:strCache>
                <c:ptCount val="2"/>
                <c:pt idx="0">
                  <c:v>Regular Worker</c:v>
                </c:pt>
                <c:pt idx="1">
                  <c:v>Part time </c:v>
                </c:pt>
              </c:strCache>
            </c:strRef>
          </c:cat>
          <c:val>
            <c:numRef>
              <c:f>Sheet6!$M$28:$M$29</c:f>
              <c:numCache>
                <c:formatCode>####.0000</c:formatCode>
                <c:ptCount val="2"/>
                <c:pt idx="0">
                  <c:v>1.5618377871542426E-2</c:v>
                </c:pt>
                <c:pt idx="1">
                  <c:v>6.448084054388133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E8-4974-83FB-F341A8B07D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8591752"/>
        <c:axId val="678589400"/>
      </c:barChart>
      <c:catAx>
        <c:axId val="678591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89400"/>
        <c:crosses val="autoZero"/>
        <c:auto val="1"/>
        <c:lblAlgn val="ctr"/>
        <c:lblOffset val="100"/>
        <c:noMultiLvlLbl val="0"/>
      </c:catAx>
      <c:valAx>
        <c:axId val="678589400"/>
        <c:scaling>
          <c:orientation val="minMax"/>
        </c:scaling>
        <c:delete val="0"/>
        <c:axPos val="l"/>
        <c:numFmt formatCode="#,##0.000_);[Red]\(#,##0.00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859175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099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1168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289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513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570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441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089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522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758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321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388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FC6E9-A827-4001-B6EE-6B9BAB91D4E6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2D1EB-E505-4C9A-90BE-BFC10CAA8B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020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4556956" y="3136613"/>
            <a:ext cx="30780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kumimoji="1" lang="ja-JP" altLang="en-US" sz="3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file 4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2555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/>
          <p:cNvSpPr txBox="1"/>
          <p:nvPr/>
        </p:nvSpPr>
        <p:spPr>
          <a:xfrm>
            <a:off x="345178" y="41377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481960" y="43821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605918" y="78622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593853" y="78622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8369981" y="78622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-27577" y="168534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-85462" y="469386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bilit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331187" y="6448814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235497" y="6448814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036</a:t>
            </a:r>
            <a:endParaRPr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184083" y="6448814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159</a:t>
            </a:r>
            <a:endParaRPr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379737" y="3022647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graphicFrame>
        <p:nvGraphicFramePr>
          <p:cNvPr id="30" name="グラフ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7258044"/>
              </p:ext>
            </p:extLst>
          </p:nvPr>
        </p:nvGraphicFramePr>
        <p:xfrm>
          <a:off x="286189" y="337813"/>
          <a:ext cx="1954393" cy="26848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1" name="グラフ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6926900"/>
              </p:ext>
            </p:extLst>
          </p:nvPr>
        </p:nvGraphicFramePr>
        <p:xfrm>
          <a:off x="2139881" y="371016"/>
          <a:ext cx="1982783" cy="2651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グラフ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6028583"/>
              </p:ext>
            </p:extLst>
          </p:nvPr>
        </p:nvGraphicFramePr>
        <p:xfrm>
          <a:off x="4211513" y="586821"/>
          <a:ext cx="2047968" cy="26114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3" name="グラフ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7756145"/>
              </p:ext>
            </p:extLst>
          </p:nvPr>
        </p:nvGraphicFramePr>
        <p:xfrm>
          <a:off x="6202680" y="606367"/>
          <a:ext cx="2027732" cy="2490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4" name="グラフ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4579717"/>
              </p:ext>
            </p:extLst>
          </p:nvPr>
        </p:nvGraphicFramePr>
        <p:xfrm>
          <a:off x="8224031" y="639029"/>
          <a:ext cx="1981519" cy="2673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5" name="グラフ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5043492"/>
              </p:ext>
            </p:extLst>
          </p:nvPr>
        </p:nvGraphicFramePr>
        <p:xfrm>
          <a:off x="10146110" y="371016"/>
          <a:ext cx="2045890" cy="2684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6" name="グラフ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3509124"/>
              </p:ext>
            </p:extLst>
          </p:nvPr>
        </p:nvGraphicFramePr>
        <p:xfrm>
          <a:off x="220827" y="3819913"/>
          <a:ext cx="2019755" cy="2505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60331"/>
              </p:ext>
            </p:extLst>
          </p:nvPr>
        </p:nvGraphicFramePr>
        <p:xfrm>
          <a:off x="2146156" y="3856088"/>
          <a:ext cx="2009763" cy="2656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8" name="グラフ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7923874"/>
              </p:ext>
            </p:extLst>
          </p:nvPr>
        </p:nvGraphicFramePr>
        <p:xfrm>
          <a:off x="4210744" y="3847271"/>
          <a:ext cx="2113684" cy="2598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39" name="グラフ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1758394"/>
              </p:ext>
            </p:extLst>
          </p:nvPr>
        </p:nvGraphicFramePr>
        <p:xfrm>
          <a:off x="6292945" y="3606688"/>
          <a:ext cx="1987534" cy="27360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0" name="グラフ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0827696"/>
              </p:ext>
            </p:extLst>
          </p:nvPr>
        </p:nvGraphicFramePr>
        <p:xfrm>
          <a:off x="8263666" y="3847272"/>
          <a:ext cx="1988447" cy="247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41" name="テキスト ボックス 40"/>
          <p:cNvSpPr txBox="1"/>
          <p:nvPr/>
        </p:nvSpPr>
        <p:spPr>
          <a:xfrm>
            <a:off x="10361264" y="29335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8518617" y="3445005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K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605918" y="3447161"/>
            <a:ext cx="5661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 I 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45178" y="3419803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469703" y="3419803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578416" y="3391931"/>
            <a:ext cx="4972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379023" y="3074168"/>
            <a:ext cx="748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011</a:t>
            </a:r>
            <a:endParaRPr lang="ja-JP" altLang="en-US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5296333" y="3123392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213643" y="3029266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9337635" y="3167765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 smtClean="0"/>
              <a:t>P=0.012</a:t>
            </a:r>
            <a:endParaRPr lang="ja-JP" altLang="en-US" dirty="0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1273454" y="3118455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9385966" y="6454978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7379023" y="6454978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ja-JP" dirty="0"/>
              <a:t>P&lt;0.001</a:t>
            </a:r>
            <a:endParaRPr lang="ja-JP" altLang="en-US" dirty="0"/>
          </a:p>
        </p:txBody>
      </p:sp>
      <p:sp>
        <p:nvSpPr>
          <p:cNvPr id="52" name="正方形/長方形 51"/>
          <p:cNvSpPr/>
          <p:nvPr/>
        </p:nvSpPr>
        <p:spPr>
          <a:xfrm>
            <a:off x="10617103" y="5561512"/>
            <a:ext cx="13030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S3 Figure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78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</TotalTime>
  <Words>51</Words>
  <Application>Microsoft Office PowerPoint</Application>
  <PresentationFormat>ワイド画面</PresentationFormat>
  <Paragraphs>2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村 義明</dc:creator>
  <cp:lastModifiedBy>野村 義明</cp:lastModifiedBy>
  <cp:revision>16</cp:revision>
  <cp:lastPrinted>2019-11-25T08:19:10Z</cp:lastPrinted>
  <dcterms:created xsi:type="dcterms:W3CDTF">2019-10-11T02:16:00Z</dcterms:created>
  <dcterms:modified xsi:type="dcterms:W3CDTF">2020-06-06T09:04:52Z</dcterms:modified>
</cp:coreProperties>
</file>